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>
        <p:scale>
          <a:sx n="75" d="100"/>
          <a:sy n="75" d="100"/>
        </p:scale>
        <p:origin x="366" y="-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475526" y="940407"/>
          <a:ext cx="4733925" cy="2551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6035040" imgH="2996280" progId="Prism5.Document">
                  <p:embed/>
                </p:oleObj>
              </mc:Choice>
              <mc:Fallback>
                <p:oleObj name="Prism 5" r:id="rId2" imgW="6035040" imgH="299628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5526" y="940407"/>
                        <a:ext cx="4733925" cy="2551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555156" y="649266"/>
            <a:ext cx="1486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ptotic MNC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98284" y="3491520"/>
            <a:ext cx="441116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Fig.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ies of apoptotic MNCs (PI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nnexin-APC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mong total MNCs isolated from bloo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otobiotic pigs were transplanted with human infant fecal microbiota (HIFM), at 4 days of age, post-HIFM transplantation day (PTD) 0. Pigs were fed a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icient diet. Probiotic was given to the respective groups at PTD 11, followed by challenge with virulent human rotavirus (HRV) on PTD 13/post-challenge day (PCD) 0 and pigs were euthanized on PTD 27/PCD 14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816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9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8:38Z</dcterms:modified>
</cp:coreProperties>
</file>